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2" autoAdjust="0"/>
    <p:restoredTop sz="94660"/>
  </p:normalViewPr>
  <p:slideViewPr>
    <p:cSldViewPr snapToGrid="0">
      <p:cViewPr varScale="1">
        <p:scale>
          <a:sx n="90" d="100"/>
          <a:sy n="90" d="100"/>
        </p:scale>
        <p:origin x="84" y="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B4F3FC-7358-7656-6DD1-E208585EE4C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067E40E-3683-6ABB-71B3-1943193860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969342-3B02-45D7-C4B9-D03C2A0A75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6E2AF-065B-44AF-A8EC-FBA489599251}" type="datetimeFigureOut">
              <a:rPr lang="en-US" smtClean="0"/>
              <a:t>8/2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6D4A46-5AFF-22DC-206B-CA017A33A7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1DD313-AB5C-3D51-D950-314B2961E3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1626B-F1A5-4BFE-A34D-CD1537B31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620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1EE9B0-C19F-9746-2915-70750EC35F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343EFA-0DD1-451B-8117-B98E85654D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60656A-B8FB-A962-CE05-E15108C2CD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6E2AF-065B-44AF-A8EC-FBA489599251}" type="datetimeFigureOut">
              <a:rPr lang="en-US" smtClean="0"/>
              <a:t>8/2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7F80B5-832F-2CE7-4E2C-B14F1C554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9953FB5-6DB7-C174-FC0D-4944D2566D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1626B-F1A5-4BFE-A34D-CD1537B31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77386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01D73EA-CF75-95F3-FE49-2991765BBD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1D8D390-C068-C8F3-4247-53B481F3DA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B64A0B-6AE7-3F01-9D78-DD30E70018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6E2AF-065B-44AF-A8EC-FBA489599251}" type="datetimeFigureOut">
              <a:rPr lang="en-US" smtClean="0"/>
              <a:t>8/2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817FDA-20CB-8CD9-909C-4572C63516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D7561C-5550-1448-F382-4CED9F6C04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1626B-F1A5-4BFE-A34D-CD1537B31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47502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22A709-6CE5-2FCD-7E0A-D7D4BB693C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A5041A-2CD9-BEF3-9DF0-1A8CDDB2C9A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0EC532-EE12-5F65-CF6B-0F703BC7CB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6E2AF-065B-44AF-A8EC-FBA489599251}" type="datetimeFigureOut">
              <a:rPr lang="en-US" smtClean="0"/>
              <a:t>8/2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DAF6BB-2B7C-7B74-F55A-8DFF6781C2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154D75-9511-9527-3B50-7C7118F327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1626B-F1A5-4BFE-A34D-CD1537B31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809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9876A0-3C33-D3D6-35ED-F1EE3D84D2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561A09-9F59-559C-3E4A-5EE1B61295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7D4733-0A07-71D7-76F6-AB33AE8A2E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6E2AF-065B-44AF-A8EC-FBA489599251}" type="datetimeFigureOut">
              <a:rPr lang="en-US" smtClean="0"/>
              <a:t>8/2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723292-1A11-2450-7D07-39123F489C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D82DAE-F90D-3E4C-C072-C8F53AF26D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1626B-F1A5-4BFE-A34D-CD1537B31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2250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5B995D-FB8A-5444-0B3D-1BF62187C2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192D8D-6CCD-5743-DA53-08597AEF1D6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A9F9511-95E1-CE42-1D63-3F2B76C5F1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7BF804-4EA9-88A6-0E29-2205C808F2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6E2AF-065B-44AF-A8EC-FBA489599251}" type="datetimeFigureOut">
              <a:rPr lang="en-US" smtClean="0"/>
              <a:t>8/2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8CE7763-AC50-F5BE-6EEC-8B7776A136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80DA3A-ADC8-6A2F-5772-E3BE380A69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1626B-F1A5-4BFE-A34D-CD1537B31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67975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06C919-9146-6704-3D4D-0FC71217784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A88276-197A-CE7D-5FFE-9BA952CE33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4A9E1F3-C436-3155-B064-C899CB0DA9B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100CA7F-AE6A-9F25-B64D-20ACDDBE068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58C89E3-72EC-9E01-F23A-398BBAF058D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157564B-B58B-AB9B-CD82-4B3AF1C8A0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6E2AF-065B-44AF-A8EC-FBA489599251}" type="datetimeFigureOut">
              <a:rPr lang="en-US" smtClean="0"/>
              <a:t>8/27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C94892D-7C9E-48C6-9202-58824E29DE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67495BF-B5CB-6F87-0143-62F85743F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1626B-F1A5-4BFE-A34D-CD1537B31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72400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D850AAF-6A87-72DF-EA17-B7E1D7C21C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0030F3B-8ABF-4322-3494-D95B86748E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6E2AF-065B-44AF-A8EC-FBA489599251}" type="datetimeFigureOut">
              <a:rPr lang="en-US" smtClean="0"/>
              <a:t>8/27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C90D3E8-336D-ABC1-7A7C-66E4F870A9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1088EB4-ED29-CB59-8B0D-DEF5A8A287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1626B-F1A5-4BFE-A34D-CD1537B31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7232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EF4C090-5D09-AEA0-4BCA-E8ED42E53E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6E2AF-065B-44AF-A8EC-FBA489599251}" type="datetimeFigureOut">
              <a:rPr lang="en-US" smtClean="0"/>
              <a:t>8/27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DAE8AD3-45D3-5281-1BE2-9244D577CF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1E12876-A049-8EF1-05DF-CEFE25E431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1626B-F1A5-4BFE-A34D-CD1537B31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75923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00A2DA-418C-5015-7F3A-CEFE7F312B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AC4C05-F496-6A1D-5BA0-5F648C33B02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20294E-F411-113A-439B-1BEE440D30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352E37-17C7-964B-D3CF-48FF3352BD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6E2AF-065B-44AF-A8EC-FBA489599251}" type="datetimeFigureOut">
              <a:rPr lang="en-US" smtClean="0"/>
              <a:t>8/2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37B8148-253F-F31D-3EAE-FA15BEC61F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A870A95-5C97-8C32-28CF-829F7B3E44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1626B-F1A5-4BFE-A34D-CD1537B31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177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4F4030-030C-5000-42DC-BB3FFCB21A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D791A06-9410-525D-04B1-254E771BB6F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07058B9-E023-49F1-55FD-25B5987DE9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F1F131F-F20E-C495-4A52-D5630B5C35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F6E2AF-065B-44AF-A8EC-FBA489599251}" type="datetimeFigureOut">
              <a:rPr lang="en-US" smtClean="0"/>
              <a:t>8/27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BC3F29C-8A1E-8CCD-BE19-9CF851785B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76EBAA6-9B61-3396-7157-DC1C83F87E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1626B-F1A5-4BFE-A34D-CD1537B31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7932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3CD4FD5-88C2-FD03-7E37-257382F907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84595E1-CE5A-7C62-7FB0-CE39F2CB2B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DC45C5-CF2F-F424-D629-50C2193117F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F6E2AF-065B-44AF-A8EC-FBA489599251}" type="datetimeFigureOut">
              <a:rPr lang="en-US" smtClean="0"/>
              <a:t>8/27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923711-74E1-089B-5832-06123355929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14E366-CBBE-71D6-A265-A48C96877CD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91626B-F1A5-4BFE-A34D-CD1537B31C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90417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FF151F59-3938-D019-729D-7FDB808D219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8976" y="199339"/>
            <a:ext cx="4240988" cy="424098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3543A3B-9FDA-AC44-2C97-6B1FF92D510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5506" y="199339"/>
            <a:ext cx="4240988" cy="424098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D3E4B227-DDE4-3880-34EE-85BE2633854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02280" y="199339"/>
            <a:ext cx="4240988" cy="4240988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0468AF03-7BE6-E512-CA0E-95ED9C3E6778}"/>
              </a:ext>
            </a:extLst>
          </p:cNvPr>
          <p:cNvSpPr txBox="1"/>
          <p:nvPr/>
        </p:nvSpPr>
        <p:spPr>
          <a:xfrm>
            <a:off x="1446027" y="4522013"/>
            <a:ext cx="14176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4C1h_vs_R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BD59373-52AA-5082-0BBE-BC5AD6F66148}"/>
              </a:ext>
            </a:extLst>
          </p:cNvPr>
          <p:cNvSpPr txBox="1"/>
          <p:nvPr/>
        </p:nvSpPr>
        <p:spPr>
          <a:xfrm>
            <a:off x="5291469" y="4522013"/>
            <a:ext cx="14176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4C2h_vs_R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1A0D4DC-B022-0D84-9252-4159BAF79DAD}"/>
              </a:ext>
            </a:extLst>
          </p:cNvPr>
          <p:cNvSpPr txBox="1"/>
          <p:nvPr/>
        </p:nvSpPr>
        <p:spPr>
          <a:xfrm>
            <a:off x="8913627" y="4522013"/>
            <a:ext cx="141767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4C4h_vs_RT</a:t>
            </a:r>
          </a:p>
        </p:txBody>
      </p:sp>
    </p:spTree>
    <p:extLst>
      <p:ext uri="{BB962C8B-B14F-4D97-AF65-F5344CB8AC3E}">
        <p14:creationId xmlns:p14="http://schemas.microsoft.com/office/powerpoint/2010/main" val="38657924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0AC97454-A641-BDC7-0FC0-137A867590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754" y="178982"/>
            <a:ext cx="4400106" cy="4400106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F8F0EF6F-FCEA-10C0-12A0-5E4E8646A4C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3414" y="178982"/>
            <a:ext cx="4400106" cy="440010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24EF949-778F-A85A-70F3-1F91635DD3D9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00" y="178982"/>
            <a:ext cx="4400106" cy="4400106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EF44E2AF-B5AC-561B-2254-5D7EF02BCC9D}"/>
              </a:ext>
            </a:extLst>
          </p:cNvPr>
          <p:cNvSpPr txBox="1"/>
          <p:nvPr/>
        </p:nvSpPr>
        <p:spPr>
          <a:xfrm>
            <a:off x="1368056" y="4642515"/>
            <a:ext cx="170829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10C1h_vs_4C1h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A1B8FBE-60D3-29F7-5767-AA80A32B210E}"/>
              </a:ext>
            </a:extLst>
          </p:cNvPr>
          <p:cNvSpPr txBox="1"/>
          <p:nvPr/>
        </p:nvSpPr>
        <p:spPr>
          <a:xfrm>
            <a:off x="5252485" y="4642515"/>
            <a:ext cx="144602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10C1h_vs_RT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106C149-BD45-3423-E519-048344CAD586}"/>
              </a:ext>
            </a:extLst>
          </p:cNvPr>
          <p:cNvSpPr txBox="1"/>
          <p:nvPr/>
        </p:nvSpPr>
        <p:spPr>
          <a:xfrm>
            <a:off x="8980081" y="4642515"/>
            <a:ext cx="167994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10C2h_vs_4C2h</a:t>
            </a:r>
          </a:p>
        </p:txBody>
      </p:sp>
    </p:spTree>
    <p:extLst>
      <p:ext uri="{BB962C8B-B14F-4D97-AF65-F5344CB8AC3E}">
        <p14:creationId xmlns:p14="http://schemas.microsoft.com/office/powerpoint/2010/main" val="363103295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65360DE7-2AD6-DD52-E4DF-708D7938870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340" y="228600"/>
            <a:ext cx="4102395" cy="410239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4629307-3F10-7310-CFB6-6ADE120B775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18614" y="228600"/>
            <a:ext cx="4102395" cy="410239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636430B-8D8B-43D4-13C2-670EF4B0995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69888" y="228600"/>
            <a:ext cx="4102395" cy="410239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61C6483-9BB9-2ED4-35AD-CCAEA35A6CEC}"/>
              </a:ext>
            </a:extLst>
          </p:cNvPr>
          <p:cNvSpPr txBox="1"/>
          <p:nvPr/>
        </p:nvSpPr>
        <p:spPr>
          <a:xfrm>
            <a:off x="694660" y="4436953"/>
            <a:ext cx="22115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/>
              <a:t>10C2h_vs_RT</a:t>
            </a:r>
            <a:endParaRPr lang="en-US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2F352D3-F8F5-3363-619B-11C22F8FB931}"/>
              </a:ext>
            </a:extLst>
          </p:cNvPr>
          <p:cNvSpPr txBox="1"/>
          <p:nvPr/>
        </p:nvSpPr>
        <p:spPr>
          <a:xfrm>
            <a:off x="4121888" y="4436953"/>
            <a:ext cx="249156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10C4h_vs_4C4h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94DB7E4-5CED-DB92-CFB4-7A921F090BC0}"/>
              </a:ext>
            </a:extLst>
          </p:cNvPr>
          <p:cNvSpPr txBox="1"/>
          <p:nvPr/>
        </p:nvSpPr>
        <p:spPr>
          <a:xfrm>
            <a:off x="7945178" y="4436953"/>
            <a:ext cx="22399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10C4h_vs_RT</a:t>
            </a:r>
          </a:p>
        </p:txBody>
      </p:sp>
    </p:spTree>
    <p:extLst>
      <p:ext uri="{BB962C8B-B14F-4D97-AF65-F5344CB8AC3E}">
        <p14:creationId xmlns:p14="http://schemas.microsoft.com/office/powerpoint/2010/main" val="14889857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04A5156-3358-95C8-844B-B369A08238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135" y="157716"/>
            <a:ext cx="4244163" cy="4244163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0CCDB9F4-DB48-071B-9800-36BEDE97E13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9116" y="157716"/>
            <a:ext cx="4244163" cy="424416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07241859-0439-C7F6-28C6-86303D47665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75451" y="157716"/>
            <a:ext cx="4244163" cy="424416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E3BAE98-E7FD-6C65-90A1-42E906991CA4}"/>
              </a:ext>
            </a:extLst>
          </p:cNvPr>
          <p:cNvSpPr txBox="1"/>
          <p:nvPr/>
        </p:nvSpPr>
        <p:spPr>
          <a:xfrm>
            <a:off x="701749" y="4493659"/>
            <a:ext cx="246675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15C1h_vs_4C1h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13A9614-EFBD-C677-F044-4CA78F264625}"/>
              </a:ext>
            </a:extLst>
          </p:cNvPr>
          <p:cNvSpPr txBox="1"/>
          <p:nvPr/>
        </p:nvSpPr>
        <p:spPr>
          <a:xfrm>
            <a:off x="4267200" y="4493659"/>
            <a:ext cx="25730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15C1h_vs_10C1h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E197FF2-6A94-27BD-57B3-85DDAF66C847}"/>
              </a:ext>
            </a:extLst>
          </p:cNvPr>
          <p:cNvSpPr txBox="1"/>
          <p:nvPr/>
        </p:nvSpPr>
        <p:spPr>
          <a:xfrm>
            <a:off x="8130363" y="4493659"/>
            <a:ext cx="221157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15C1h_vs_RT</a:t>
            </a:r>
          </a:p>
        </p:txBody>
      </p:sp>
    </p:spTree>
    <p:extLst>
      <p:ext uri="{BB962C8B-B14F-4D97-AF65-F5344CB8AC3E}">
        <p14:creationId xmlns:p14="http://schemas.microsoft.com/office/powerpoint/2010/main" val="351997041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2990786F-C2B4-C208-F998-B603DD75E83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3285" y="299485"/>
            <a:ext cx="4279604" cy="427960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BB8D60C-8845-E99A-8106-12522CDDCA6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2149" y="299485"/>
            <a:ext cx="4279604" cy="427960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6AA18E9-6E9B-B89A-C6C3-E5BECE7E409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38484" y="299485"/>
            <a:ext cx="4279604" cy="4279604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BA2C39C-BDE2-ED23-6DCC-312B70E431C9}"/>
              </a:ext>
            </a:extLst>
          </p:cNvPr>
          <p:cNvSpPr txBox="1"/>
          <p:nvPr/>
        </p:nvSpPr>
        <p:spPr>
          <a:xfrm>
            <a:off x="854149" y="4791371"/>
            <a:ext cx="256244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15C2h_vs_4C2h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BBD3A69-D2F2-843B-42C0-AF076EDB7DFE}"/>
              </a:ext>
            </a:extLst>
          </p:cNvPr>
          <p:cNvSpPr txBox="1"/>
          <p:nvPr/>
        </p:nvSpPr>
        <p:spPr>
          <a:xfrm>
            <a:off x="4430233" y="4791371"/>
            <a:ext cx="28920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15C2h_vs_10C2h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8C5D4AA-4531-B4C7-F7EE-B295197C747D}"/>
              </a:ext>
            </a:extLst>
          </p:cNvPr>
          <p:cNvSpPr txBox="1"/>
          <p:nvPr/>
        </p:nvSpPr>
        <p:spPr>
          <a:xfrm>
            <a:off x="8463516" y="4791371"/>
            <a:ext cx="220448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15C2h_vs_RT</a:t>
            </a:r>
          </a:p>
        </p:txBody>
      </p:sp>
    </p:spTree>
    <p:extLst>
      <p:ext uri="{BB962C8B-B14F-4D97-AF65-F5344CB8AC3E}">
        <p14:creationId xmlns:p14="http://schemas.microsoft.com/office/powerpoint/2010/main" val="17262146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F4C8B51-7A04-1482-39F4-1BCBBB273B2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299484"/>
            <a:ext cx="4385930" cy="438593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5D82470-4A04-2031-0263-FBFE643B929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34046" y="299484"/>
            <a:ext cx="4385930" cy="438593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B7F5F11-8795-A01B-4FA4-07B85036F1D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53672" y="299484"/>
            <a:ext cx="4385930" cy="438593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5DE913B-B300-31DE-5B2D-2392B796BE0D}"/>
              </a:ext>
            </a:extLst>
          </p:cNvPr>
          <p:cNvSpPr txBox="1"/>
          <p:nvPr/>
        </p:nvSpPr>
        <p:spPr>
          <a:xfrm>
            <a:off x="886046" y="4883520"/>
            <a:ext cx="2516373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15C4h_vs_4C4h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82719E7-2503-BA12-AD48-F827FBCE3482}"/>
              </a:ext>
            </a:extLst>
          </p:cNvPr>
          <p:cNvSpPr txBox="1"/>
          <p:nvPr/>
        </p:nvSpPr>
        <p:spPr>
          <a:xfrm>
            <a:off x="4749210" y="4883520"/>
            <a:ext cx="226827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dirty="0"/>
              <a:t>15C4h_vs_10C4h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6670F41-5B5F-EA48-F736-FAC43044A763}"/>
              </a:ext>
            </a:extLst>
          </p:cNvPr>
          <p:cNvSpPr txBox="1"/>
          <p:nvPr/>
        </p:nvSpPr>
        <p:spPr>
          <a:xfrm>
            <a:off x="9063372" y="4883520"/>
            <a:ext cx="156653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15C4h_vs_RT</a:t>
            </a:r>
          </a:p>
        </p:txBody>
      </p:sp>
    </p:spTree>
    <p:extLst>
      <p:ext uri="{BB962C8B-B14F-4D97-AF65-F5344CB8AC3E}">
        <p14:creationId xmlns:p14="http://schemas.microsoft.com/office/powerpoint/2010/main" val="17646681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0</Words>
  <Application>Microsoft Office PowerPoint</Application>
  <PresentationFormat>Widescreen</PresentationFormat>
  <Paragraphs>1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Weeramange Madushi vishmitha</dc:creator>
  <cp:lastModifiedBy>Weeramange Madushi vishmitha</cp:lastModifiedBy>
  <cp:revision>1</cp:revision>
  <dcterms:created xsi:type="dcterms:W3CDTF">2025-08-27T09:41:31Z</dcterms:created>
  <dcterms:modified xsi:type="dcterms:W3CDTF">2025-08-27T09:42:19Z</dcterms:modified>
</cp:coreProperties>
</file>